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3" r:id="rId1"/>
  </p:sldMasterIdLst>
  <p:notesMasterIdLst>
    <p:notesMasterId r:id="rId3"/>
  </p:notesMasterIdLst>
  <p:sldIdLst>
    <p:sldId id="30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ie, Hongli" initials="XH" lastIdx="8" clrIdx="0">
    <p:extLst/>
  </p:cmAuthor>
  <p:cmAuthor id="2" name="Tang, Yuhong" initials="TY" lastIdx="1" clrIdx="1">
    <p:extLst/>
  </p:cmAuthor>
  <p:cmAuthor id="3" name="Blancaflor, Elison" initials="BE" lastIdx="5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94125" autoAdjust="0"/>
  </p:normalViewPr>
  <p:slideViewPr>
    <p:cSldViewPr snapToGrid="0">
      <p:cViewPr varScale="1">
        <p:scale>
          <a:sx n="109" d="100"/>
          <a:sy n="109" d="100"/>
        </p:scale>
        <p:origin x="1800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5" d="100"/>
        <a:sy n="95" d="100"/>
      </p:scale>
      <p:origin x="0" y="-130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7AF8FC-282C-4D50-A8E4-D2E2BE1ACA9E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F050B-F196-4082-B381-D05887F97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8764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21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963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797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688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913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817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394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391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155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824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375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91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4" r:id="rId1"/>
    <p:sldLayoutId id="2147483725" r:id="rId2"/>
    <p:sldLayoutId id="2147483726" r:id="rId3"/>
    <p:sldLayoutId id="2147483727" r:id="rId4"/>
    <p:sldLayoutId id="2147483728" r:id="rId5"/>
    <p:sldLayoutId id="2147483729" r:id="rId6"/>
    <p:sldLayoutId id="2147483730" r:id="rId7"/>
    <p:sldLayoutId id="2147483731" r:id="rId8"/>
    <p:sldLayoutId id="2147483732" r:id="rId9"/>
    <p:sldLayoutId id="2147483733" r:id="rId10"/>
    <p:sldLayoutId id="214748373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746359"/>
              </p:ext>
            </p:extLst>
          </p:nvPr>
        </p:nvGraphicFramePr>
        <p:xfrm>
          <a:off x="667951" y="1511794"/>
          <a:ext cx="7874000" cy="3619500"/>
        </p:xfrm>
        <a:graphic>
          <a:graphicData uri="http://schemas.openxmlformats.org/drawingml/2006/table">
            <a:tbl>
              <a:tblPr/>
              <a:tblGrid>
                <a:gridCol w="134565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11563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39528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7803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2295155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name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NA length (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DNA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ength (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rpose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DFB-639-F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ACTTGACCTGGAAGAAGAC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7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1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1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ing, RT-PC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DFB-2100-R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ATTGGTATCTCCTCGTTA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1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ing, RT-PC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r F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CAACCGTGTACGTCTCC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1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enotypin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L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TGTCGAACTTGGGAATT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1bp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in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R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TTTCAAAGACCGGTGACC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in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1.3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TTGCCGATTTCGGAAC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in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1QF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CTGATTTGCCAGAGAAT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5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1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-PCR for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1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t5g05980)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1QR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CATGGGTAGTGAAGTAAA  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-PCR for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2QF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GAGAAATCAATCCAAGG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5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5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-PCR for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2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t3g10160)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2QR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AAGTGAAGGCATTACGG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-PCR for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3QF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GGGATCTTCGACAAACG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1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1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-PCR for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3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t3g55630)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3QR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CAGGAAGTGACGAGAAA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-PCR for </a:t>
                      </a:r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GS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mt1QF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GTTCTTGATGAAATCGTT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PCR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t4g34050)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Q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CCGACGGCAGATAGT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PCR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Q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CTGTCGTGGCTCCTCCT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5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5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-PCR for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t4g34050)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QR     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CCGACGGCAGATAGTGA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-PCR for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oAOM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ACTIN2F1: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TCCAGCAGATGTGGATCTC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7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3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Q)RT-PCR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nal standard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ACTIN2R1: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CAGAGCTACAAAACAATGGG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Q)RT-PCR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nal standard</a:t>
                      </a:r>
                    </a:p>
                  </a:txBody>
                  <a:tcPr marL="9525" marR="9525" marT="952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667951" y="1057633"/>
            <a:ext cx="7874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1.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mers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ed for genotyping and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analysis by RT-PCR and QRT-PCR.</a:t>
            </a:r>
            <a:endParaRPr 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1595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661</TotalTime>
  <Words>157</Words>
  <Application>Microsoft Office PowerPoint</Application>
  <PresentationFormat>On-screen Show (4:3)</PresentationFormat>
  <Paragraphs>9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e, Hongli</dc:creator>
  <cp:lastModifiedBy>Xie, Hongli</cp:lastModifiedBy>
  <cp:revision>516</cp:revision>
  <cp:lastPrinted>2017-10-20T14:57:19Z</cp:lastPrinted>
  <dcterms:created xsi:type="dcterms:W3CDTF">2017-05-21T20:10:06Z</dcterms:created>
  <dcterms:modified xsi:type="dcterms:W3CDTF">2019-04-11T02:54:42Z</dcterms:modified>
</cp:coreProperties>
</file>